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145705851" r:id="rId2"/>
  </p:sldIdLst>
  <p:sldSz cx="13288963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91B60"/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426"/>
    <p:restoredTop sz="96327"/>
  </p:normalViewPr>
  <p:slideViewPr>
    <p:cSldViewPr snapToGrid="0">
      <p:cViewPr varScale="1">
        <p:scale>
          <a:sx n="66" d="100"/>
          <a:sy n="66" d="100"/>
        </p:scale>
        <p:origin x="388" y="2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963E54A-A776-4540-B731-6FED89DF8ED1}" type="datetimeFigureOut">
              <a:rPr lang="en-US" smtClean="0"/>
              <a:t>2/11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39738" y="1143000"/>
            <a:ext cx="59785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39CD057-A7B6-0843-A5EB-2F74B44171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10131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439738" y="1143000"/>
            <a:ext cx="59785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Eligibility as of 9/2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9C0F53C-96F6-46BE-8B84-E4EEF713604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29015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661121" y="1122363"/>
            <a:ext cx="9966722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61121" y="3602038"/>
            <a:ext cx="9966722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B09A1-C619-2D47-B469-B36A91808F22}" type="datetimeFigureOut">
              <a:rPr lang="en-US" smtClean="0"/>
              <a:t>2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F2C28-3283-A04F-B064-C042AAEA08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54688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B09A1-C619-2D47-B469-B36A91808F22}" type="datetimeFigureOut">
              <a:rPr lang="en-US" smtClean="0"/>
              <a:t>2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F2C28-3283-A04F-B064-C042AAEA08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50674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509914" y="365125"/>
            <a:ext cx="2865433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13616" y="365125"/>
            <a:ext cx="8430186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B09A1-C619-2D47-B469-B36A91808F22}" type="datetimeFigureOut">
              <a:rPr lang="en-US" smtClean="0"/>
              <a:t>2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F2C28-3283-A04F-B064-C042AAEA08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63663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B09A1-C619-2D47-B469-B36A91808F22}" type="datetimeFigureOut">
              <a:rPr lang="en-US" smtClean="0"/>
              <a:t>2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F2C28-3283-A04F-B064-C042AAEA08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93587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6695" y="1709738"/>
            <a:ext cx="11461731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6695" y="4589464"/>
            <a:ext cx="11461731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B09A1-C619-2D47-B469-B36A91808F22}" type="datetimeFigureOut">
              <a:rPr lang="en-US" smtClean="0"/>
              <a:t>2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F2C28-3283-A04F-B064-C042AAEA08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6052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13616" y="1825625"/>
            <a:ext cx="5647809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727538" y="1825625"/>
            <a:ext cx="5647809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B09A1-C619-2D47-B469-B36A91808F22}" type="datetimeFigureOut">
              <a:rPr lang="en-US" smtClean="0"/>
              <a:t>2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F2C28-3283-A04F-B064-C042AAEA08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83790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5347" y="365126"/>
            <a:ext cx="11461731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5347" y="1681163"/>
            <a:ext cx="5621854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5347" y="2505075"/>
            <a:ext cx="5621854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727538" y="1681163"/>
            <a:ext cx="56495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727538" y="2505075"/>
            <a:ext cx="56495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B09A1-C619-2D47-B469-B36A91808F22}" type="datetimeFigureOut">
              <a:rPr lang="en-US" smtClean="0"/>
              <a:t>2/11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F2C28-3283-A04F-B064-C042AAEA08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49500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B09A1-C619-2D47-B469-B36A91808F22}" type="datetimeFigureOut">
              <a:rPr lang="en-US" smtClean="0"/>
              <a:t>2/11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F2C28-3283-A04F-B064-C042AAEA08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62187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B09A1-C619-2D47-B469-B36A91808F22}" type="datetimeFigureOut">
              <a:rPr lang="en-US" smtClean="0"/>
              <a:t>2/11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F2C28-3283-A04F-B064-C042AAEA08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71851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5348" y="457200"/>
            <a:ext cx="42860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649540" y="987426"/>
            <a:ext cx="6727538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5348" y="2057400"/>
            <a:ext cx="42860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B09A1-C619-2D47-B469-B36A91808F22}" type="datetimeFigureOut">
              <a:rPr lang="en-US" smtClean="0"/>
              <a:t>2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F2C28-3283-A04F-B064-C042AAEA08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01385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5348" y="457200"/>
            <a:ext cx="42860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649540" y="987426"/>
            <a:ext cx="6727538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5348" y="2057400"/>
            <a:ext cx="42860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B09A1-C619-2D47-B469-B36A91808F22}" type="datetimeFigureOut">
              <a:rPr lang="en-US" smtClean="0"/>
              <a:t>2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F2C28-3283-A04F-B064-C042AAEA08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6213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13616" y="365126"/>
            <a:ext cx="11461731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3616" y="1825625"/>
            <a:ext cx="11461731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13616" y="6356351"/>
            <a:ext cx="299001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0B09A1-C619-2D47-B469-B36A91808F22}" type="datetimeFigureOut">
              <a:rPr lang="en-US" smtClean="0"/>
              <a:t>2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401969" y="6356351"/>
            <a:ext cx="448502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385330" y="6356351"/>
            <a:ext cx="299001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CF2C28-3283-A04F-B064-C042AAEA08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35370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CB42254F-EA99-6845-A656-AFD70AB6BE8D}"/>
              </a:ext>
            </a:extLst>
          </p:cNvPr>
          <p:cNvSpPr/>
          <p:nvPr/>
        </p:nvSpPr>
        <p:spPr>
          <a:xfrm>
            <a:off x="2389451" y="2322471"/>
            <a:ext cx="2294490" cy="593491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dirty="0">
                <a:solidFill>
                  <a:schemeClr val="bg1"/>
                </a:solidFill>
              </a:rPr>
              <a:t>Dynamic Choice HIV Prevention (N=769)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06A4B93B-0F60-074D-BB00-3D06587817F0}"/>
              </a:ext>
            </a:extLst>
          </p:cNvPr>
          <p:cNvSpPr/>
          <p:nvPr/>
        </p:nvSpPr>
        <p:spPr>
          <a:xfrm>
            <a:off x="2354726" y="4263679"/>
            <a:ext cx="2294490" cy="593491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dirty="0"/>
              <a:t>Standard of Care Prevention (N=765)</a:t>
            </a:r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939E5CB1-37ED-EE4E-AB48-87426FF5E06C}"/>
              </a:ext>
            </a:extLst>
          </p:cNvPr>
          <p:cNvSpPr/>
          <p:nvPr/>
        </p:nvSpPr>
        <p:spPr>
          <a:xfrm>
            <a:off x="37346" y="3081816"/>
            <a:ext cx="2242746" cy="1061120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dirty="0">
                <a:solidFill>
                  <a:sysClr val="windowText" lastClr="000000"/>
                </a:solidFill>
              </a:rPr>
              <a:t>Randomized</a:t>
            </a:r>
          </a:p>
          <a:p>
            <a:pPr algn="ctr"/>
            <a:r>
              <a:rPr lang="en-US" sz="2000" dirty="0">
                <a:solidFill>
                  <a:sysClr val="windowText" lastClr="000000"/>
                </a:solidFill>
              </a:rPr>
              <a:t>N=1534 participants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CD796CEF-B7DF-534D-81FE-8CBD668B39FE}"/>
              </a:ext>
            </a:extLst>
          </p:cNvPr>
          <p:cNvCxnSpPr>
            <a:cxnSpLocks/>
            <a:stCxn id="6" idx="0"/>
            <a:endCxn id="4" idx="1"/>
          </p:cNvCxnSpPr>
          <p:nvPr/>
        </p:nvCxnSpPr>
        <p:spPr>
          <a:xfrm flipV="1">
            <a:off x="1158719" y="2619217"/>
            <a:ext cx="1230732" cy="462599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019C6349-265E-4044-AFAF-2B8AFF07EBA5}"/>
              </a:ext>
            </a:extLst>
          </p:cNvPr>
          <p:cNvCxnSpPr>
            <a:cxnSpLocks/>
            <a:stCxn id="6" idx="4"/>
            <a:endCxn id="5" idx="1"/>
          </p:cNvCxnSpPr>
          <p:nvPr/>
        </p:nvCxnSpPr>
        <p:spPr>
          <a:xfrm>
            <a:off x="1158719" y="4142936"/>
            <a:ext cx="1196007" cy="417489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7E4267AE-0644-EC4B-8E1B-71CA23AC80B5}"/>
              </a:ext>
            </a:extLst>
          </p:cNvPr>
          <p:cNvCxnSpPr>
            <a:cxnSpLocks/>
          </p:cNvCxnSpPr>
          <p:nvPr/>
        </p:nvCxnSpPr>
        <p:spPr>
          <a:xfrm>
            <a:off x="6185020" y="2250818"/>
            <a:ext cx="0" cy="3053469"/>
          </a:xfrm>
          <a:prstGeom prst="line">
            <a:avLst/>
          </a:prstGeom>
          <a:ln w="25400">
            <a:solidFill>
              <a:schemeClr val="accent6">
                <a:lumMod val="40000"/>
                <a:lumOff val="6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343B6B48-7B0D-534F-A1DF-A1EC430931F1}"/>
              </a:ext>
            </a:extLst>
          </p:cNvPr>
          <p:cNvCxnSpPr>
            <a:cxnSpLocks/>
          </p:cNvCxnSpPr>
          <p:nvPr/>
        </p:nvCxnSpPr>
        <p:spPr>
          <a:xfrm>
            <a:off x="4649216" y="4560191"/>
            <a:ext cx="1481328" cy="0"/>
          </a:xfrm>
          <a:prstGeom prst="straightConnector1">
            <a:avLst/>
          </a:prstGeom>
          <a:ln w="38100">
            <a:solidFill>
              <a:schemeClr val="accent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837EE89B-E01B-8247-8DDC-BCCCA4F3CB85}"/>
              </a:ext>
            </a:extLst>
          </p:cNvPr>
          <p:cNvCxnSpPr>
            <a:cxnSpLocks/>
          </p:cNvCxnSpPr>
          <p:nvPr/>
        </p:nvCxnSpPr>
        <p:spPr>
          <a:xfrm>
            <a:off x="4653018" y="2610304"/>
            <a:ext cx="1481564" cy="0"/>
          </a:xfrm>
          <a:prstGeom prst="straightConnector1">
            <a:avLst/>
          </a:prstGeom>
          <a:ln w="3810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D5E99452-67AA-1F46-8757-01BE14969D90}"/>
              </a:ext>
            </a:extLst>
          </p:cNvPr>
          <p:cNvSpPr txBox="1"/>
          <p:nvPr/>
        </p:nvSpPr>
        <p:spPr>
          <a:xfrm>
            <a:off x="5355171" y="5187563"/>
            <a:ext cx="165969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Extension start</a:t>
            </a:r>
            <a:br>
              <a:rPr lang="en-US" dirty="0"/>
            </a:br>
            <a:r>
              <a:rPr lang="en-US" dirty="0"/>
              <a:t>(Jan 2023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FFDBCED-EF0E-93CE-10C2-E69F029F1A09}"/>
              </a:ext>
            </a:extLst>
          </p:cNvPr>
          <p:cNvSpPr txBox="1"/>
          <p:nvPr/>
        </p:nvSpPr>
        <p:spPr>
          <a:xfrm>
            <a:off x="2412601" y="724064"/>
            <a:ext cx="3535426" cy="830997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/>
              <a:t>SEARCH Dynamic Choice HIV Prevention Studies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545328B-638E-39EE-4CF0-96A664485375}"/>
              </a:ext>
            </a:extLst>
          </p:cNvPr>
          <p:cNvSpPr txBox="1"/>
          <p:nvPr/>
        </p:nvSpPr>
        <p:spPr>
          <a:xfrm>
            <a:off x="6913748" y="718276"/>
            <a:ext cx="5899427" cy="830997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/>
              <a:t>SEARCH CAB-LA Dynamic Choice </a:t>
            </a:r>
          </a:p>
          <a:p>
            <a:pPr algn="ctr"/>
            <a:r>
              <a:rPr lang="en-US" sz="2400" b="1" dirty="0"/>
              <a:t>HIV Prevention Extension Study</a:t>
            </a: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0B6AA59C-D02F-A363-8D50-F9E63FCD977F}"/>
              </a:ext>
            </a:extLst>
          </p:cNvPr>
          <p:cNvSpPr/>
          <p:nvPr/>
        </p:nvSpPr>
        <p:spPr>
          <a:xfrm>
            <a:off x="6217870" y="2108335"/>
            <a:ext cx="2294490" cy="830996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dirty="0">
                <a:solidFill>
                  <a:schemeClr val="bg1"/>
                </a:solidFill>
              </a:rPr>
              <a:t>CAB-LA + Dynamic Choice HIV Prevention (N=487)</a:t>
            </a: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884A6C0E-BAE1-508A-0261-C565C261EA1E}"/>
              </a:ext>
            </a:extLst>
          </p:cNvPr>
          <p:cNvSpPr/>
          <p:nvPr/>
        </p:nvSpPr>
        <p:spPr>
          <a:xfrm>
            <a:off x="6217870" y="4281551"/>
            <a:ext cx="2294490" cy="593491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dirty="0"/>
              <a:t>Standard of Care Prevention (N=497)</a:t>
            </a:r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D11889AC-0D6D-EEDC-F7E7-992F2BDEE4DA}"/>
              </a:ext>
            </a:extLst>
          </p:cNvPr>
          <p:cNvCxnSpPr>
            <a:cxnSpLocks/>
          </p:cNvCxnSpPr>
          <p:nvPr/>
        </p:nvCxnSpPr>
        <p:spPr>
          <a:xfrm>
            <a:off x="10013439" y="2274186"/>
            <a:ext cx="0" cy="3053469"/>
          </a:xfrm>
          <a:prstGeom prst="line">
            <a:avLst/>
          </a:prstGeom>
          <a:ln w="25400">
            <a:solidFill>
              <a:schemeClr val="accent6">
                <a:lumMod val="40000"/>
                <a:lumOff val="6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5DE6D01A-D1CC-29D4-F1A4-8319E6486F98}"/>
              </a:ext>
            </a:extLst>
          </p:cNvPr>
          <p:cNvCxnSpPr>
            <a:cxnSpLocks/>
          </p:cNvCxnSpPr>
          <p:nvPr/>
        </p:nvCxnSpPr>
        <p:spPr>
          <a:xfrm>
            <a:off x="8499732" y="4560191"/>
            <a:ext cx="1481328" cy="0"/>
          </a:xfrm>
          <a:prstGeom prst="straightConnector1">
            <a:avLst/>
          </a:prstGeom>
          <a:ln w="38100">
            <a:solidFill>
              <a:schemeClr val="accent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659A845A-9687-C8DE-7E5C-E1FD1D9CFD4A}"/>
              </a:ext>
            </a:extLst>
          </p:cNvPr>
          <p:cNvCxnSpPr>
            <a:cxnSpLocks/>
          </p:cNvCxnSpPr>
          <p:nvPr/>
        </p:nvCxnSpPr>
        <p:spPr>
          <a:xfrm>
            <a:off x="8481437" y="2633672"/>
            <a:ext cx="1481564" cy="0"/>
          </a:xfrm>
          <a:prstGeom prst="straightConnector1">
            <a:avLst/>
          </a:prstGeom>
          <a:ln w="3810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F401A097-11E2-39F6-A5E8-8C5DE466B73C}"/>
              </a:ext>
            </a:extLst>
          </p:cNvPr>
          <p:cNvSpPr txBox="1"/>
          <p:nvPr/>
        </p:nvSpPr>
        <p:spPr>
          <a:xfrm>
            <a:off x="9191813" y="5268034"/>
            <a:ext cx="16432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48-weeks</a:t>
            </a:r>
          </a:p>
        </p:txBody>
      </p: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F8CA0AFA-C71B-F1CC-D7D0-EC7C40275F72}"/>
              </a:ext>
            </a:extLst>
          </p:cNvPr>
          <p:cNvCxnSpPr>
            <a:cxnSpLocks/>
          </p:cNvCxnSpPr>
          <p:nvPr/>
        </p:nvCxnSpPr>
        <p:spPr>
          <a:xfrm>
            <a:off x="10013439" y="2636245"/>
            <a:ext cx="1481564" cy="0"/>
          </a:xfrm>
          <a:prstGeom prst="straightConnector1">
            <a:avLst/>
          </a:prstGeom>
          <a:ln w="3810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662C0058-CBB7-E5C9-9F14-08B982435C6B}"/>
              </a:ext>
            </a:extLst>
          </p:cNvPr>
          <p:cNvCxnSpPr>
            <a:cxnSpLocks/>
          </p:cNvCxnSpPr>
          <p:nvPr/>
        </p:nvCxnSpPr>
        <p:spPr>
          <a:xfrm>
            <a:off x="11495003" y="2250817"/>
            <a:ext cx="0" cy="3053469"/>
          </a:xfrm>
          <a:prstGeom prst="line">
            <a:avLst/>
          </a:prstGeom>
          <a:ln w="25400">
            <a:solidFill>
              <a:schemeClr val="accent6">
                <a:lumMod val="40000"/>
                <a:lumOff val="6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86BC581B-FCF8-9187-6DC6-F6FB27ECA6A9}"/>
              </a:ext>
            </a:extLst>
          </p:cNvPr>
          <p:cNvSpPr txBox="1"/>
          <p:nvPr/>
        </p:nvSpPr>
        <p:spPr>
          <a:xfrm>
            <a:off x="10884724" y="5268033"/>
            <a:ext cx="19284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tudy close</a:t>
            </a:r>
          </a:p>
          <a:p>
            <a:r>
              <a:rPr lang="en-US" dirty="0"/>
              <a:t>96-weeks</a:t>
            </a:r>
            <a:br>
              <a:rPr lang="en-US" dirty="0"/>
            </a:br>
            <a:r>
              <a:rPr lang="en-US" dirty="0"/>
              <a:t>(Dec 2024)</a:t>
            </a:r>
          </a:p>
        </p:txBody>
      </p:sp>
    </p:spTree>
    <p:extLst>
      <p:ext uri="{BB962C8B-B14F-4D97-AF65-F5344CB8AC3E}">
        <p14:creationId xmlns:p14="http://schemas.microsoft.com/office/powerpoint/2010/main" val="8967957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0955</TotalTime>
  <Words>78</Words>
  <Application>Microsoft Office PowerPoint</Application>
  <PresentationFormat>Custom</PresentationFormat>
  <Paragraphs>1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AB-LA extension to Dynamic Choice Trials</dc:title>
  <dc:creator>Laura Balzer</dc:creator>
  <cp:lastModifiedBy>Elijah kakande</cp:lastModifiedBy>
  <cp:revision>10</cp:revision>
  <dcterms:created xsi:type="dcterms:W3CDTF">2023-04-11T18:49:44Z</dcterms:created>
  <dcterms:modified xsi:type="dcterms:W3CDTF">2025-02-11T12:36:14Z</dcterms:modified>
</cp:coreProperties>
</file>